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18" autoAdjust="0"/>
    <p:restoredTop sz="94660"/>
  </p:normalViewPr>
  <p:slideViewPr>
    <p:cSldViewPr snapToGrid="0">
      <p:cViewPr>
        <p:scale>
          <a:sx n="46" d="100"/>
          <a:sy n="46" d="100"/>
        </p:scale>
        <p:origin x="16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aank\Downloads\luminal%20functions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aank\Downloads\Basal%20Pathways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aank\Downloads\Basal%20Functional%20Groups2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676380525963667"/>
          <c:y val="3.8707028068170057E-2"/>
          <c:w val="0.80526233853121298"/>
          <c:h val="0.39816884104604222"/>
        </c:manualLayout>
      </c:layout>
      <c:barChart>
        <c:barDir val="col"/>
        <c:grouping val="stacked"/>
        <c:varyColors val="0"/>
        <c:ser>
          <c:idx val="0"/>
          <c:order val="0"/>
          <c:tx>
            <c:v>Luminal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0!$I$2:$I$13</c:f>
              <c:strCache>
                <c:ptCount val="12"/>
                <c:pt idx="0">
                  <c:v>Accumulation of macrophages</c:v>
                </c:pt>
                <c:pt idx="1">
                  <c:v>Aggregation of blood cells</c:v>
                </c:pt>
                <c:pt idx="2">
                  <c:v>Aggregation of tumor cell lines</c:v>
                </c:pt>
                <c:pt idx="3">
                  <c:v>Angiogenesis</c:v>
                </c:pt>
                <c:pt idx="4">
                  <c:v>Apoptosis</c:v>
                </c:pt>
                <c:pt idx="5">
                  <c:v>Cell movement</c:v>
                </c:pt>
                <c:pt idx="6">
                  <c:v>Cell proliferation of fibroblasts</c:v>
                </c:pt>
                <c:pt idx="7">
                  <c:v>Interaction of cancer cells</c:v>
                </c:pt>
                <c:pt idx="8">
                  <c:v>Invasion of tumor</c:v>
                </c:pt>
                <c:pt idx="9">
                  <c:v>Migration of cells</c:v>
                </c:pt>
                <c:pt idx="10">
                  <c:v>Proliferation of connective tissue cells</c:v>
                </c:pt>
                <c:pt idx="11">
                  <c:v>Reorganization of cytoskeleton</c:v>
                </c:pt>
              </c:strCache>
            </c:strRef>
          </c:cat>
          <c:val>
            <c:numRef>
              <c:f>Sheet0!$J$2:$J$13</c:f>
              <c:numCache>
                <c:formatCode>General</c:formatCode>
                <c:ptCount val="12"/>
                <c:pt idx="0">
                  <c:v>-2.5880000000000001</c:v>
                </c:pt>
                <c:pt idx="2">
                  <c:v>1.359</c:v>
                </c:pt>
                <c:pt idx="3">
                  <c:v>-1.302</c:v>
                </c:pt>
                <c:pt idx="4">
                  <c:v>-0.52600000000000002</c:v>
                </c:pt>
                <c:pt idx="5">
                  <c:v>-2.2010000000000001</c:v>
                </c:pt>
                <c:pt idx="7">
                  <c:v>1.5740000000000001</c:v>
                </c:pt>
                <c:pt idx="8">
                  <c:v>-1.994</c:v>
                </c:pt>
                <c:pt idx="9">
                  <c:v>-2.0750000000000002</c:v>
                </c:pt>
                <c:pt idx="10">
                  <c:v>-1.5629999999999999</c:v>
                </c:pt>
                <c:pt idx="11">
                  <c:v>-1.8680000000000001</c:v>
                </c:pt>
              </c:numCache>
            </c:numRef>
          </c:val>
        </c:ser>
        <c:ser>
          <c:idx val="1"/>
          <c:order val="1"/>
          <c:tx>
            <c:v>Basal</c:v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0!$I$2:$I$13</c:f>
              <c:strCache>
                <c:ptCount val="12"/>
                <c:pt idx="0">
                  <c:v>Accumulation of macrophages</c:v>
                </c:pt>
                <c:pt idx="1">
                  <c:v>Aggregation of blood cells</c:v>
                </c:pt>
                <c:pt idx="2">
                  <c:v>Aggregation of tumor cell lines</c:v>
                </c:pt>
                <c:pt idx="3">
                  <c:v>Angiogenesis</c:v>
                </c:pt>
                <c:pt idx="4">
                  <c:v>Apoptosis</c:v>
                </c:pt>
                <c:pt idx="5">
                  <c:v>Cell movement</c:v>
                </c:pt>
                <c:pt idx="6">
                  <c:v>Cell proliferation of fibroblasts</c:v>
                </c:pt>
                <c:pt idx="7">
                  <c:v>Interaction of cancer cells</c:v>
                </c:pt>
                <c:pt idx="8">
                  <c:v>Invasion of tumor</c:v>
                </c:pt>
                <c:pt idx="9">
                  <c:v>Migration of cells</c:v>
                </c:pt>
                <c:pt idx="10">
                  <c:v>Proliferation of connective tissue cells</c:v>
                </c:pt>
                <c:pt idx="11">
                  <c:v>Reorganization of cytoskeleton</c:v>
                </c:pt>
              </c:strCache>
            </c:strRef>
          </c:cat>
          <c:val>
            <c:numRef>
              <c:f>Sheet0!$K$2:$K$13</c:f>
              <c:numCache>
                <c:formatCode>General</c:formatCode>
                <c:ptCount val="12"/>
                <c:pt idx="1">
                  <c:v>1.7270000000000001</c:v>
                </c:pt>
                <c:pt idx="3">
                  <c:v>1.0820000000000001</c:v>
                </c:pt>
                <c:pt idx="4">
                  <c:v>-1.482</c:v>
                </c:pt>
                <c:pt idx="5">
                  <c:v>3.4420000000000002</c:v>
                </c:pt>
                <c:pt idx="6">
                  <c:v>2.415</c:v>
                </c:pt>
                <c:pt idx="7">
                  <c:v>-0.97099999999999997</c:v>
                </c:pt>
                <c:pt idx="8">
                  <c:v>1.7949999999999999</c:v>
                </c:pt>
                <c:pt idx="9">
                  <c:v>2.8519999999999999</c:v>
                </c:pt>
                <c:pt idx="10">
                  <c:v>2.028</c:v>
                </c:pt>
                <c:pt idx="11">
                  <c:v>1.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2624848"/>
        <c:axId val="352621712"/>
      </c:barChart>
      <c:catAx>
        <c:axId val="352624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b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2621712"/>
        <c:crosses val="autoZero"/>
        <c:auto val="1"/>
        <c:lblAlgn val="ctr"/>
        <c:lblOffset val="100"/>
        <c:noMultiLvlLbl val="0"/>
      </c:catAx>
      <c:valAx>
        <c:axId val="3526217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sz="1100" b="0"/>
                </a:pPr>
                <a:r>
                  <a:rPr lang="en-US" sz="1100" b="0" dirty="0"/>
                  <a:t>Activation z-score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2624848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31758543049765836"/>
          <c:y val="3.7838260674910466E-2"/>
          <c:w val="0.20386663644106401"/>
          <c:h val="5.863544024080925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58836395450568"/>
          <c:y val="3.4399893133379704E-2"/>
          <c:w val="0.82643777983634403"/>
          <c:h val="0.371596278527138"/>
        </c:manualLayout>
      </c:layout>
      <c:barChart>
        <c:barDir val="col"/>
        <c:grouping val="stacked"/>
        <c:varyColors val="0"/>
        <c:ser>
          <c:idx val="0"/>
          <c:order val="0"/>
          <c:tx>
            <c:v>Luminal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0!$H$3:$H$16</c:f>
              <c:strCache>
                <c:ptCount val="14"/>
                <c:pt idx="0">
                  <c:v>14-3-3-mediated Signaling</c:v>
                </c:pt>
                <c:pt idx="1">
                  <c:v>Actin Cytoskeleton Signaling</c:v>
                </c:pt>
                <c:pt idx="2">
                  <c:v>EIF2 Signaling</c:v>
                </c:pt>
                <c:pt idx="3">
                  <c:v>G2/M DNA Damage Checkpoint Regulation</c:v>
                </c:pt>
                <c:pt idx="4">
                  <c:v>GP6 Signaling Pathway</c:v>
                </c:pt>
                <c:pt idx="5">
                  <c:v>HIPPO signaling</c:v>
                </c:pt>
                <c:pt idx="6">
                  <c:v>ILK Signaling</c:v>
                </c:pt>
                <c:pt idx="7">
                  <c:v>Leukocyte Extravasation Signaling</c:v>
                </c:pt>
                <c:pt idx="8">
                  <c:v>mTOR Signaling</c:v>
                </c:pt>
                <c:pt idx="9">
                  <c:v>NRF2-mediated Oxidative Stress Response</c:v>
                </c:pt>
                <c:pt idx="10">
                  <c:v>PI3K/AKT Signaling</c:v>
                </c:pt>
                <c:pt idx="11">
                  <c:v>Protein Kinase A Signaling</c:v>
                </c:pt>
                <c:pt idx="12">
                  <c:v>RhoGDI Signaling</c:v>
                </c:pt>
                <c:pt idx="13">
                  <c:v>Signaling by Rho Family GTPases</c:v>
                </c:pt>
              </c:strCache>
            </c:strRef>
          </c:cat>
          <c:val>
            <c:numRef>
              <c:f>Sheet0!$I$3:$I$16</c:f>
              <c:numCache>
                <c:formatCode>General</c:formatCode>
                <c:ptCount val="14"/>
                <c:pt idx="0">
                  <c:v>-2.4489999999999998</c:v>
                </c:pt>
                <c:pt idx="1">
                  <c:v>-2.3330000000000002</c:v>
                </c:pt>
                <c:pt idx="2">
                  <c:v>-0.81599999999999995</c:v>
                </c:pt>
                <c:pt idx="3">
                  <c:v>-2</c:v>
                </c:pt>
                <c:pt idx="4">
                  <c:v>-2.2360000000000002</c:v>
                </c:pt>
                <c:pt idx="5">
                  <c:v>1.89</c:v>
                </c:pt>
                <c:pt idx="6">
                  <c:v>-0.90500000000000003</c:v>
                </c:pt>
                <c:pt idx="7">
                  <c:v>-0.70699999999999996</c:v>
                </c:pt>
                <c:pt idx="8">
                  <c:v>0.44700000000000001</c:v>
                </c:pt>
                <c:pt idx="9">
                  <c:v>0</c:v>
                </c:pt>
                <c:pt idx="10">
                  <c:v>-1.1339999999999999</c:v>
                </c:pt>
                <c:pt idx="11">
                  <c:v>-2.1110000000000002</c:v>
                </c:pt>
                <c:pt idx="12">
                  <c:v>0.30199999999999999</c:v>
                </c:pt>
                <c:pt idx="13">
                  <c:v>0</c:v>
                </c:pt>
              </c:numCache>
            </c:numRef>
          </c:val>
        </c:ser>
        <c:ser>
          <c:idx val="1"/>
          <c:order val="1"/>
          <c:tx>
            <c:v>Basal</c:v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0!$H$3:$H$16</c:f>
              <c:strCache>
                <c:ptCount val="14"/>
                <c:pt idx="0">
                  <c:v>14-3-3-mediated Signaling</c:v>
                </c:pt>
                <c:pt idx="1">
                  <c:v>Actin Cytoskeleton Signaling</c:v>
                </c:pt>
                <c:pt idx="2">
                  <c:v>EIF2 Signaling</c:v>
                </c:pt>
                <c:pt idx="3">
                  <c:v>G2/M DNA Damage Checkpoint Regulation</c:v>
                </c:pt>
                <c:pt idx="4">
                  <c:v>GP6 Signaling Pathway</c:v>
                </c:pt>
                <c:pt idx="5">
                  <c:v>HIPPO signaling</c:v>
                </c:pt>
                <c:pt idx="6">
                  <c:v>ILK Signaling</c:v>
                </c:pt>
                <c:pt idx="7">
                  <c:v>Leukocyte Extravasation Signaling</c:v>
                </c:pt>
                <c:pt idx="8">
                  <c:v>mTOR Signaling</c:v>
                </c:pt>
                <c:pt idx="9">
                  <c:v>NRF2-mediated Oxidative Stress Response</c:v>
                </c:pt>
                <c:pt idx="10">
                  <c:v>PI3K/AKT Signaling</c:v>
                </c:pt>
                <c:pt idx="11">
                  <c:v>Protein Kinase A Signaling</c:v>
                </c:pt>
                <c:pt idx="12">
                  <c:v>RhoGDI Signaling</c:v>
                </c:pt>
                <c:pt idx="13">
                  <c:v>Signaling by Rho Family GTPases</c:v>
                </c:pt>
              </c:strCache>
            </c:strRef>
          </c:cat>
          <c:val>
            <c:numRef>
              <c:f>Sheet0!$J$3:$J$16</c:f>
              <c:numCache>
                <c:formatCode>General</c:formatCode>
                <c:ptCount val="14"/>
                <c:pt idx="0">
                  <c:v>2.2360000000000002</c:v>
                </c:pt>
                <c:pt idx="1">
                  <c:v>1.633</c:v>
                </c:pt>
                <c:pt idx="2">
                  <c:v>0</c:v>
                </c:pt>
                <c:pt idx="3">
                  <c:v>0</c:v>
                </c:pt>
                <c:pt idx="4">
                  <c:v>2</c:v>
                </c:pt>
                <c:pt idx="5">
                  <c:v>-1</c:v>
                </c:pt>
                <c:pt idx="6">
                  <c:v>1</c:v>
                </c:pt>
                <c:pt idx="7">
                  <c:v>2.121</c:v>
                </c:pt>
                <c:pt idx="8">
                  <c:v>0</c:v>
                </c:pt>
                <c:pt idx="9">
                  <c:v>0.44700000000000001</c:v>
                </c:pt>
                <c:pt idx="10">
                  <c:v>1.633</c:v>
                </c:pt>
                <c:pt idx="11">
                  <c:v>2.8279999999999998</c:v>
                </c:pt>
                <c:pt idx="12">
                  <c:v>-0.81599999999999995</c:v>
                </c:pt>
                <c:pt idx="13">
                  <c:v>0.815999999999999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41911208"/>
        <c:axId val="541908856"/>
      </c:barChart>
      <c:catAx>
        <c:axId val="541911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1908856"/>
        <c:crosses val="autoZero"/>
        <c:auto val="1"/>
        <c:lblAlgn val="ctr"/>
        <c:lblOffset val="100"/>
        <c:noMultiLvlLbl val="0"/>
      </c:catAx>
      <c:valAx>
        <c:axId val="5419088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/>
                  <a:t>Activation z-scor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1911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0337476197828211"/>
          <c:y val="1.9870349194808044E-2"/>
          <c:w val="0.21351185330631986"/>
          <c:h val="7.755351952473153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5895733621532605"/>
          <c:y val="8.152170818343225E-3"/>
          <c:w val="0.61147573465081573"/>
          <c:h val="0.85663334392463553"/>
        </c:manualLayout>
      </c:layout>
      <c:barChart>
        <c:barDir val="bar"/>
        <c:grouping val="clustered"/>
        <c:varyColors val="0"/>
        <c:ser>
          <c:idx val="1"/>
          <c:order val="0"/>
          <c:tx>
            <c:v>Basal</c:v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0!$I$3:$I$21</c:f>
              <c:strCache>
                <c:ptCount val="19"/>
                <c:pt idx="0">
                  <c:v>Organismal Injury and Abnormalities</c:v>
                </c:pt>
                <c:pt idx="1">
                  <c:v>Cell-To-Cell Signaling and Interaction</c:v>
                </c:pt>
                <c:pt idx="2">
                  <c:v>Cardiovascular System Development and Function</c:v>
                </c:pt>
                <c:pt idx="3">
                  <c:v>Organismal Development</c:v>
                </c:pt>
                <c:pt idx="4">
                  <c:v>Protein Trafficking</c:v>
                </c:pt>
                <c:pt idx="5">
                  <c:v>Protein Folding</c:v>
                </c:pt>
                <c:pt idx="6">
                  <c:v>Embryonic Development</c:v>
                </c:pt>
                <c:pt idx="7">
                  <c:v>Post-Translational Modification</c:v>
                </c:pt>
                <c:pt idx="8">
                  <c:v>Connective Tissue Development and Function</c:v>
                </c:pt>
                <c:pt idx="9">
                  <c:v>Tissue Development</c:v>
                </c:pt>
                <c:pt idx="10">
                  <c:v>Inflammatory Response</c:v>
                </c:pt>
                <c:pt idx="11">
                  <c:v>Cellular Assembly and Organization</c:v>
                </c:pt>
                <c:pt idx="12">
                  <c:v>Cellular Function and Maintenance</c:v>
                </c:pt>
                <c:pt idx="13">
                  <c:v>Tumor Morphology</c:v>
                </c:pt>
                <c:pt idx="14">
                  <c:v>Cancer</c:v>
                </c:pt>
                <c:pt idx="15">
                  <c:v>Protein Synthesis</c:v>
                </c:pt>
                <c:pt idx="16">
                  <c:v>Cellular Development</c:v>
                </c:pt>
                <c:pt idx="17">
                  <c:v>Cellular Growth and Proliferation</c:v>
                </c:pt>
                <c:pt idx="18">
                  <c:v>Organismal Survival</c:v>
                </c:pt>
              </c:strCache>
            </c:strRef>
          </c:cat>
          <c:val>
            <c:numRef>
              <c:f>Sheet0!$K$3:$K$21</c:f>
              <c:numCache>
                <c:formatCode>General</c:formatCode>
                <c:ptCount val="19"/>
                <c:pt idx="0">
                  <c:v>47.317959504033055</c:v>
                </c:pt>
                <c:pt idx="1">
                  <c:v>41.790002434018135</c:v>
                </c:pt>
                <c:pt idx="2">
                  <c:v>32.968319375340407</c:v>
                </c:pt>
                <c:pt idx="3">
                  <c:v>30.678261795740063</c:v>
                </c:pt>
                <c:pt idx="4">
                  <c:v>24.69180394281323</c:v>
                </c:pt>
                <c:pt idx="5">
                  <c:v>18.375752414262536</c:v>
                </c:pt>
                <c:pt idx="6">
                  <c:v>19.598144835598983</c:v>
                </c:pt>
                <c:pt idx="7">
                  <c:v>21.869446857416378</c:v>
                </c:pt>
                <c:pt idx="8">
                  <c:v>24.250614155678416</c:v>
                </c:pt>
                <c:pt idx="9">
                  <c:v>24.250614155678416</c:v>
                </c:pt>
                <c:pt idx="10">
                  <c:v>25.641852120837875</c:v>
                </c:pt>
                <c:pt idx="11">
                  <c:v>27.013732037700592</c:v>
                </c:pt>
                <c:pt idx="12">
                  <c:v>24.660860235604961</c:v>
                </c:pt>
                <c:pt idx="13">
                  <c:v>21.908668167214095</c:v>
                </c:pt>
                <c:pt idx="14">
                  <c:v>42.543519204448188</c:v>
                </c:pt>
                <c:pt idx="15">
                  <c:v>25.546855606902128</c:v>
                </c:pt>
                <c:pt idx="16">
                  <c:v>20.987459770216219</c:v>
                </c:pt>
                <c:pt idx="17">
                  <c:v>22.602732105094635</c:v>
                </c:pt>
                <c:pt idx="18">
                  <c:v>25.634318448152467</c:v>
                </c:pt>
              </c:numCache>
            </c:numRef>
          </c:val>
        </c:ser>
        <c:ser>
          <c:idx val="0"/>
          <c:order val="1"/>
          <c:tx>
            <c:v>Luminal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0!$I$3:$I$21</c:f>
              <c:strCache>
                <c:ptCount val="19"/>
                <c:pt idx="0">
                  <c:v>Organismal Injury and Abnormalities</c:v>
                </c:pt>
                <c:pt idx="1">
                  <c:v>Cell-To-Cell Signaling and Interaction</c:v>
                </c:pt>
                <c:pt idx="2">
                  <c:v>Cardiovascular System Development and Function</c:v>
                </c:pt>
                <c:pt idx="3">
                  <c:v>Organismal Development</c:v>
                </c:pt>
                <c:pt idx="4">
                  <c:v>Protein Trafficking</c:v>
                </c:pt>
                <c:pt idx="5">
                  <c:v>Protein Folding</c:v>
                </c:pt>
                <c:pt idx="6">
                  <c:v>Embryonic Development</c:v>
                </c:pt>
                <c:pt idx="7">
                  <c:v>Post-Translational Modification</c:v>
                </c:pt>
                <c:pt idx="8">
                  <c:v>Connective Tissue Development and Function</c:v>
                </c:pt>
                <c:pt idx="9">
                  <c:v>Tissue Development</c:v>
                </c:pt>
                <c:pt idx="10">
                  <c:v>Inflammatory Response</c:v>
                </c:pt>
                <c:pt idx="11">
                  <c:v>Cellular Assembly and Organization</c:v>
                </c:pt>
                <c:pt idx="12">
                  <c:v>Cellular Function and Maintenance</c:v>
                </c:pt>
                <c:pt idx="13">
                  <c:v>Tumor Morphology</c:v>
                </c:pt>
                <c:pt idx="14">
                  <c:v>Cancer</c:v>
                </c:pt>
                <c:pt idx="15">
                  <c:v>Protein Synthesis</c:v>
                </c:pt>
                <c:pt idx="16">
                  <c:v>Cellular Development</c:v>
                </c:pt>
                <c:pt idx="17">
                  <c:v>Cellular Growth and Proliferation</c:v>
                </c:pt>
                <c:pt idx="18">
                  <c:v>Organismal Survival</c:v>
                </c:pt>
              </c:strCache>
            </c:strRef>
          </c:cat>
          <c:val>
            <c:numRef>
              <c:f>Sheet0!$J$3:$J$21</c:f>
              <c:numCache>
                <c:formatCode>General</c:formatCode>
                <c:ptCount val="19"/>
                <c:pt idx="0">
                  <c:v>46.726263291946701</c:v>
                </c:pt>
                <c:pt idx="1">
                  <c:v>41.684263180478553</c:v>
                </c:pt>
                <c:pt idx="2">
                  <c:v>33.477706101454828</c:v>
                </c:pt>
                <c:pt idx="3">
                  <c:v>35.124369301848162</c:v>
                </c:pt>
                <c:pt idx="4">
                  <c:v>23.239141371234467</c:v>
                </c:pt>
                <c:pt idx="5">
                  <c:v>26.373790897929251</c:v>
                </c:pt>
                <c:pt idx="6">
                  <c:v>27.890157352582058</c:v>
                </c:pt>
                <c:pt idx="7">
                  <c:v>29.485926608259799</c:v>
                </c:pt>
                <c:pt idx="8">
                  <c:v>29.009827583244675</c:v>
                </c:pt>
                <c:pt idx="9">
                  <c:v>31.049355947431312</c:v>
                </c:pt>
                <c:pt idx="10">
                  <c:v>40.504740876691699</c:v>
                </c:pt>
                <c:pt idx="11">
                  <c:v>43.008742460895249</c:v>
                </c:pt>
                <c:pt idx="12">
                  <c:v>43.008742460895249</c:v>
                </c:pt>
                <c:pt idx="13">
                  <c:v>44.09015358651024</c:v>
                </c:pt>
                <c:pt idx="14">
                  <c:v>46.726263291946701</c:v>
                </c:pt>
                <c:pt idx="15">
                  <c:v>57.162437492473011</c:v>
                </c:pt>
                <c:pt idx="16">
                  <c:v>59.98735078591492</c:v>
                </c:pt>
                <c:pt idx="17">
                  <c:v>59.98735078591492</c:v>
                </c:pt>
                <c:pt idx="18">
                  <c:v>68.7970158686597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06365544"/>
        <c:axId val="506366720"/>
      </c:barChart>
      <c:catAx>
        <c:axId val="5063655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6366720"/>
        <c:crosses val="autoZero"/>
        <c:auto val="1"/>
        <c:lblAlgn val="ctr"/>
        <c:lblOffset val="100"/>
        <c:noMultiLvlLbl val="0"/>
      </c:catAx>
      <c:valAx>
        <c:axId val="5063667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Enrichment -log</a:t>
                </a:r>
                <a:r>
                  <a:rPr lang="en-US" sz="1000" baseline="0"/>
                  <a:t> p-value</a:t>
                </a:r>
                <a:endParaRPr lang="en-US" sz="10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6365544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82641269106067627"/>
          <c:y val="0.29158680483191146"/>
          <c:w val="7.920063300910915E-2"/>
          <c:h val="0.209426201970437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866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139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708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702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447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120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216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136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581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05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717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2F513-FB91-4286-A7D2-4FDA90541E1C}" type="datetimeFigureOut">
              <a:rPr lang="en-US" smtClean="0"/>
              <a:t>9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1F34EF-F897-4B63-9D50-004D7896C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031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1005103"/>
              </p:ext>
            </p:extLst>
          </p:nvPr>
        </p:nvGraphicFramePr>
        <p:xfrm>
          <a:off x="0" y="3512316"/>
          <a:ext cx="7772400" cy="32342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9370156"/>
              </p:ext>
            </p:extLst>
          </p:nvPr>
        </p:nvGraphicFramePr>
        <p:xfrm>
          <a:off x="0" y="6746582"/>
          <a:ext cx="7772400" cy="33118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2056988"/>
              </p:ext>
            </p:extLst>
          </p:nvPr>
        </p:nvGraphicFramePr>
        <p:xfrm>
          <a:off x="0" y="0"/>
          <a:ext cx="7772400" cy="35123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0" y="15831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)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0" y="3528147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-8016" y="6746582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  <a:r>
              <a:rPr lang="en-US" dirty="0" smtClean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78294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3</TotalTime>
  <Words>14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Ankney</dc:creator>
  <cp:lastModifiedBy>John Ankney</cp:lastModifiedBy>
  <cp:revision>7</cp:revision>
  <dcterms:created xsi:type="dcterms:W3CDTF">2018-09-11T13:53:01Z</dcterms:created>
  <dcterms:modified xsi:type="dcterms:W3CDTF">2018-09-18T02:37:13Z</dcterms:modified>
</cp:coreProperties>
</file>